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23760113" cy="13698538"/>
  <p:notesSz cx="6858000" cy="9144000"/>
  <p:defaultTextStyle>
    <a:defPPr>
      <a:defRPr lang="ja-JP"/>
    </a:defPPr>
    <a:lvl1pPr marL="0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37" userDrawn="1">
          <p15:clr>
            <a:srgbClr val="A4A3A4"/>
          </p15:clr>
        </p15:guide>
        <p15:guide id="2" pos="6026" userDrawn="1">
          <p15:clr>
            <a:srgbClr val="A4A3A4"/>
          </p15:clr>
        </p15:guide>
        <p15:guide id="3" pos="2401" userDrawn="1">
          <p15:clr>
            <a:srgbClr val="A4A3A4"/>
          </p15:clr>
        </p15:guide>
        <p15:guide id="4" pos="11416" userDrawn="1">
          <p15:clr>
            <a:srgbClr val="A4A3A4"/>
          </p15:clr>
        </p15:guide>
        <p15:guide id="5" orient="horz" pos="459" userDrawn="1">
          <p15:clr>
            <a:srgbClr val="A4A3A4"/>
          </p15:clr>
        </p15:guide>
        <p15:guide id="6" orient="horz" pos="7626" userDrawn="1">
          <p15:clr>
            <a:srgbClr val="A4A3A4"/>
          </p15:clr>
        </p15:guide>
        <p15:guide id="7" pos="1224" userDrawn="1">
          <p15:clr>
            <a:srgbClr val="A4A3A4"/>
          </p15:clr>
        </p15:guide>
        <p15:guide id="8" pos="6939" userDrawn="1">
          <p15:clr>
            <a:srgbClr val="A4A3A4"/>
          </p15:clr>
        </p15:guide>
        <p15:guide id="9" orient="horz" pos="3566" userDrawn="1">
          <p15:clr>
            <a:srgbClr val="A4A3A4"/>
          </p15:clr>
        </p15:guide>
        <p15:guide id="10" orient="horz" pos="43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yama Izuma" initials="NI" lastIdx="22" clrIdx="0">
    <p:extLst>
      <p:ext uri="{19B8F6BF-5375-455C-9EA6-DF929625EA0E}">
        <p15:presenceInfo xmlns:p15="http://schemas.microsoft.com/office/powerpoint/2012/main" userId="57dc3945d2166f67" providerId="Windows Live"/>
      </p:ext>
    </p:extLst>
  </p:cmAuthor>
  <p:cmAuthor id="2" name="下嵜啓太郎" initials="下嵜啓太郎" lastIdx="8" clrIdx="1">
    <p:extLst>
      <p:ext uri="{19B8F6BF-5375-455C-9EA6-DF929625EA0E}">
        <p15:presenceInfo xmlns:p15="http://schemas.microsoft.com/office/powerpoint/2012/main" userId="759013536612368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2B38"/>
    <a:srgbClr val="005493"/>
    <a:srgbClr val="D9DEED"/>
    <a:srgbClr val="D9DE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7"/>
    <p:restoredTop sz="89439"/>
  </p:normalViewPr>
  <p:slideViewPr>
    <p:cSldViewPr snapToGrid="0" snapToObjects="1" showGuides="1">
      <p:cViewPr>
        <p:scale>
          <a:sx n="151" d="100"/>
          <a:sy n="151" d="100"/>
        </p:scale>
        <p:origin x="104" y="128"/>
      </p:cViewPr>
      <p:guideLst>
        <p:guide orient="horz" pos="4337"/>
        <p:guide pos="6026"/>
        <p:guide pos="2401"/>
        <p:guide pos="11416"/>
        <p:guide orient="horz" pos="459"/>
        <p:guide orient="horz" pos="7626"/>
        <p:guide pos="1224"/>
        <p:guide pos="6939"/>
        <p:guide orient="horz" pos="3566"/>
        <p:guide orient="horz" pos="43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36AEA-D790-F74D-BC9D-BF7A4DB89FE8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52475" y="1143000"/>
            <a:ext cx="5353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12144-BE04-BB46-BAF5-2B46214D0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2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236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</a:t>
            </a:r>
            <a:r>
              <a:rPr kumimoji="1" lang="en-US" altLang="ja-JP" sz="236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aplan–Meier estimates of progression-free survival according to the </a:t>
            </a:r>
            <a:r>
              <a:rPr kumimoji="1" lang="en-US" altLang="ja-JP" sz="236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FCR clinical prognostic </a:t>
            </a:r>
            <a:r>
              <a:rPr kumimoji="1" lang="en-US" altLang="ja-JP" sz="236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ex.</a:t>
            </a:r>
            <a:endParaRPr kumimoji="1" lang="ja-JP" altLang="ja-JP" sz="236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412144-BE04-BB46-BAF5-2B46214D041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200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245413-6788-2B4C-9373-C47D59752E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970014" y="2241868"/>
            <a:ext cx="17820085" cy="4769121"/>
          </a:xfrm>
        </p:spPr>
        <p:txBody>
          <a:bodyPr anchor="b"/>
          <a:lstStyle>
            <a:lvl1pPr algn="ctr"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E7B1C56-EA5A-6C43-96D4-E0D7C48A6C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970014" y="7194904"/>
            <a:ext cx="17820085" cy="3307308"/>
          </a:xfrm>
        </p:spPr>
        <p:txBody>
          <a:bodyPr/>
          <a:lstStyle>
            <a:lvl1pPr marL="0" indent="0" algn="ctr">
              <a:buNone/>
              <a:defRPr sz="4677"/>
            </a:lvl1pPr>
            <a:lvl2pPr marL="890991" indent="0" algn="ctr">
              <a:buNone/>
              <a:defRPr sz="3898"/>
            </a:lvl2pPr>
            <a:lvl3pPr marL="1781983" indent="0" algn="ctr">
              <a:buNone/>
              <a:defRPr sz="3508"/>
            </a:lvl3pPr>
            <a:lvl4pPr marL="2672974" indent="0" algn="ctr">
              <a:buNone/>
              <a:defRPr sz="3118"/>
            </a:lvl4pPr>
            <a:lvl5pPr marL="3563965" indent="0" algn="ctr">
              <a:buNone/>
              <a:defRPr sz="3118"/>
            </a:lvl5pPr>
            <a:lvl6pPr marL="4454957" indent="0" algn="ctr">
              <a:buNone/>
              <a:defRPr sz="3118"/>
            </a:lvl6pPr>
            <a:lvl7pPr marL="5345948" indent="0" algn="ctr">
              <a:buNone/>
              <a:defRPr sz="3118"/>
            </a:lvl7pPr>
            <a:lvl8pPr marL="6236940" indent="0" algn="ctr">
              <a:buNone/>
              <a:defRPr sz="3118"/>
            </a:lvl8pPr>
            <a:lvl9pPr marL="7127931" indent="0" algn="ctr">
              <a:buNone/>
              <a:defRPr sz="3118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25B8E8-48F3-FE45-A259-3007FF006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5450B2-DF15-204B-97B7-45AEB3FA4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499627-4C77-C042-9C33-49D598DD2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880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8B38F-8A53-2146-822C-03F70A5F6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0F4321-DD1D-AA4D-B2D5-6141788C05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AC2B8B-F3EA-EF47-9FD2-2E24AF490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DA0236-8C8E-C445-AFE3-853F553D2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D5E371-474A-9B4D-AED5-E2D9AA392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69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F0D98B-D173-7249-A791-B2C39DFBDE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7003331" y="729320"/>
            <a:ext cx="5123274" cy="1160887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126A16C-A007-EA45-BD9A-C44C5D04A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633508" y="729320"/>
            <a:ext cx="15072822" cy="1160887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84D828-113E-5741-A902-231E7BCC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18295A-419C-DB4A-8A51-AF976B52D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360BD-DD90-5747-B960-9AFCD1450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31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0995B1-3E8A-5444-AD0D-8226CBF32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18AB91-6F55-8747-A37A-39E5967F71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DD9E7F-1BC1-C244-91AA-F4F9B250E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D9C338-FA7D-2C4A-A2DD-F0B6ED2D9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AEEED8-91AB-C74C-AEAC-F5042061A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72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D99A0D-4717-0A46-A966-1FEC849848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1133" y="3415128"/>
            <a:ext cx="20493097" cy="5698210"/>
          </a:xfrm>
        </p:spPr>
        <p:txBody>
          <a:bodyPr anchor="b"/>
          <a:lstStyle>
            <a:lvl1pPr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5AC2D5-DC25-FA40-9D90-B6CDE4477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21133" y="9167245"/>
            <a:ext cx="20493097" cy="2996554"/>
          </a:xfrm>
        </p:spPr>
        <p:txBody>
          <a:bodyPr/>
          <a:lstStyle>
            <a:lvl1pPr marL="0" indent="0">
              <a:buNone/>
              <a:defRPr sz="4677">
                <a:solidFill>
                  <a:schemeClr val="tx1">
                    <a:tint val="75000"/>
                  </a:schemeClr>
                </a:solidFill>
              </a:defRPr>
            </a:lvl1pPr>
            <a:lvl2pPr marL="890991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2pPr>
            <a:lvl3pPr marL="1781983" indent="0">
              <a:buNone/>
              <a:defRPr sz="3508">
                <a:solidFill>
                  <a:schemeClr val="tx1">
                    <a:tint val="75000"/>
                  </a:schemeClr>
                </a:solidFill>
              </a:defRPr>
            </a:lvl3pPr>
            <a:lvl4pPr marL="2672974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4pPr>
            <a:lvl5pPr marL="3563965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5pPr>
            <a:lvl6pPr marL="4454957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6pPr>
            <a:lvl7pPr marL="5345948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7pPr>
            <a:lvl8pPr marL="6236940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8pPr>
            <a:lvl9pPr marL="7127931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C3CFF1-D0CE-524A-8AB7-32AADEFD0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2E143D-7B5A-1C48-91ED-9BEE292B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8007CA-3D6A-1B44-9F59-0AE01DCC9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65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FA2F9B-A514-1948-8ED6-5243ABD76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3B15E9-0B49-A846-91C8-7B236CD099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633508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9329E0-7B91-5946-8C5B-E5F6313B9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2028557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A2B9979-EC31-D941-B991-28A6E9A6F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4A55BD-BEC8-164F-B6C0-DBA18B3FC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BC9221-85BA-2B49-AD36-C7A4CCB39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98DB9F-BD80-384A-B4F9-8C365683D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3" y="729325"/>
            <a:ext cx="20493097" cy="2647751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354C6C-503D-FE4B-BCB6-963DAB6E21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6605" y="3358045"/>
            <a:ext cx="10051641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DFC96E3-8B8B-194C-AA50-4114777A9F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636605" y="5003772"/>
            <a:ext cx="10051641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F559E01-1877-9846-A63A-7C4A283013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12028557" y="3358045"/>
            <a:ext cx="10101143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1606AD-078C-1A4C-82A9-69B000CDF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12028557" y="5003772"/>
            <a:ext cx="10101143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5E94413-0DA0-604E-9AC6-13C80C991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0B1DA5-9646-5A48-93AA-0AE615C26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73432D8-7D56-2944-8FEA-04F30B372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596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F7D4ED-8889-1941-A39E-E6BCC173F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FD3F1BF-5DBF-A640-95E3-BF2C523A3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592A65A-B585-0243-9CEE-F4C3DF6AA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101D531-BC13-EB4C-9687-45480C03D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027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3CAA49B-321E-6644-A136-D465EB4AE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D96588C-8889-BF4F-BE08-241C64154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DA4F96-1DD4-CA4D-B323-6C0010528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921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86B29B-2BC8-FB48-B02F-1DF798A81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E6EF6A-6A84-8347-A36E-EA1B9D8CC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>
              <a:defRPr sz="6236"/>
            </a:lvl1pPr>
            <a:lvl2pPr>
              <a:defRPr sz="5457"/>
            </a:lvl2pPr>
            <a:lvl3pPr>
              <a:defRPr sz="4677"/>
            </a:lvl3pPr>
            <a:lvl4pPr>
              <a:defRPr sz="3898"/>
            </a:lvl4pPr>
            <a:lvl5pPr>
              <a:defRPr sz="3898"/>
            </a:lvl5pPr>
            <a:lvl6pPr>
              <a:defRPr sz="3898"/>
            </a:lvl6pPr>
            <a:lvl7pPr>
              <a:defRPr sz="3898"/>
            </a:lvl7pPr>
            <a:lvl8pPr>
              <a:defRPr sz="3898"/>
            </a:lvl8pPr>
            <a:lvl9pPr>
              <a:defRPr sz="3898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F5E05A8-DCB7-814E-9F90-197C62983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EE2390-36B8-4E4B-B50D-A32DDA256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BE7513-43CA-7948-9E0D-830153426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E36DD5-DF0C-8648-BDEC-65AFF2FFD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92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742DBD-157F-BE49-88D3-986DDD12C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B2C6636-8F7E-FA44-AB01-2C1007A7F5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 marL="0" indent="0">
              <a:buNone/>
              <a:defRPr sz="6236"/>
            </a:lvl1pPr>
            <a:lvl2pPr marL="890991" indent="0">
              <a:buNone/>
              <a:defRPr sz="5457"/>
            </a:lvl2pPr>
            <a:lvl3pPr marL="1781983" indent="0">
              <a:buNone/>
              <a:defRPr sz="4677"/>
            </a:lvl3pPr>
            <a:lvl4pPr marL="2672974" indent="0">
              <a:buNone/>
              <a:defRPr sz="3898"/>
            </a:lvl4pPr>
            <a:lvl5pPr marL="3563965" indent="0">
              <a:buNone/>
              <a:defRPr sz="3898"/>
            </a:lvl5pPr>
            <a:lvl6pPr marL="4454957" indent="0">
              <a:buNone/>
              <a:defRPr sz="3898"/>
            </a:lvl6pPr>
            <a:lvl7pPr marL="5345948" indent="0">
              <a:buNone/>
              <a:defRPr sz="3898"/>
            </a:lvl7pPr>
            <a:lvl8pPr marL="6236940" indent="0">
              <a:buNone/>
              <a:defRPr sz="3898"/>
            </a:lvl8pPr>
            <a:lvl9pPr marL="7127931" indent="0">
              <a:buNone/>
              <a:defRPr sz="3898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3BC946-7D0D-994A-A1DD-7ED3C02B97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23FF658-7A1C-0546-A39F-B376438F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72B273-AC43-AD46-BC7E-134FD309E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5CEFA7-62A9-0A49-A839-2FAA545FE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532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C82FAC-8691-D148-8E09-B49F46EBD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3508" y="729325"/>
            <a:ext cx="20493097" cy="2647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436E9F-9649-D64D-83CB-0D39C8F1AA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3508" y="3646601"/>
            <a:ext cx="20493097" cy="86915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AFE54B-F4D3-494D-9F02-C020FF4B3E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633508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6C04196D-1171-3B4A-BAE1-6B6D8949F670}" type="datetimeFigureOut">
              <a:rPr lang="ja-JP" altLang="en-US" smtClean="0"/>
              <a:pPr/>
              <a:t>2021/6/17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2CF07-A504-0E44-B83D-839D090A7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7870538" y="12696520"/>
            <a:ext cx="8019038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9E7CF3-FE54-2441-8A09-BA3C3D0A6E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6780580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97FE01E6-B555-7547-BEFB-252F8AE8412B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59875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781983" rtl="0" eaLnBrk="1" latinLnBrk="0" hangingPunct="1">
        <a:lnSpc>
          <a:spcPct val="90000"/>
        </a:lnSpc>
        <a:spcBef>
          <a:spcPct val="0"/>
        </a:spcBef>
        <a:buNone/>
        <a:defRPr kumimoji="1" sz="8575" b="1" kern="1200">
          <a:solidFill>
            <a:schemeClr val="accent4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</p:titleStyle>
    <p:bodyStyle>
      <a:lvl1pPr marL="445496" indent="-445496" algn="l" defTabSz="1781983" rtl="0" eaLnBrk="1" latinLnBrk="0" hangingPunct="1">
        <a:lnSpc>
          <a:spcPct val="90000"/>
        </a:lnSpc>
        <a:spcBef>
          <a:spcPts val="1949"/>
        </a:spcBef>
        <a:buFont typeface="Arial" panose="020B0604020202020204" pitchFamily="34" charset="0"/>
        <a:buChar char="•"/>
        <a:defRPr kumimoji="1" sz="545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  <a:lvl2pPr marL="133648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467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2pPr>
      <a:lvl3pPr marL="2227478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89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3pPr>
      <a:lvl4pPr marL="3118470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4pPr>
      <a:lvl5pPr marL="4009461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5pPr>
      <a:lvl6pPr marL="4900452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791444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682435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57342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1pPr>
      <a:lvl2pPr marL="89099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2pPr>
      <a:lvl3pPr marL="1781983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3pPr>
      <a:lvl4pPr marL="2672974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3563965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454957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345948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23694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12793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478CFD69-5492-564E-AADD-C950369774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054" t="2611" r="3482" b="15149"/>
          <a:stretch/>
        </p:blipFill>
        <p:spPr>
          <a:xfrm>
            <a:off x="1989556" y="704581"/>
            <a:ext cx="7342731" cy="4986161"/>
          </a:xfrm>
          <a:prstGeom prst="rect">
            <a:avLst/>
          </a:prstGeom>
        </p:spPr>
      </p:pic>
      <p:grpSp>
        <p:nvGrpSpPr>
          <p:cNvPr id="506" name="グループ化 505">
            <a:extLst>
              <a:ext uri="{FF2B5EF4-FFF2-40B4-BE49-F238E27FC236}">
                <a16:creationId xmlns:a16="http://schemas.microsoft.com/office/drawing/2014/main" id="{5B10A89B-3E6B-4942-A377-9B7BEB375D88}"/>
              </a:ext>
            </a:extLst>
          </p:cNvPr>
          <p:cNvGrpSpPr/>
          <p:nvPr/>
        </p:nvGrpSpPr>
        <p:grpSpPr>
          <a:xfrm>
            <a:off x="1205393" y="535306"/>
            <a:ext cx="8554801" cy="5685588"/>
            <a:chOff x="1198696" y="559386"/>
            <a:chExt cx="8554801" cy="5685588"/>
          </a:xfrm>
        </p:grpSpPr>
        <p:grpSp>
          <p:nvGrpSpPr>
            <p:cNvPr id="507" name="グループ化 506">
              <a:extLst>
                <a:ext uri="{FF2B5EF4-FFF2-40B4-BE49-F238E27FC236}">
                  <a16:creationId xmlns:a16="http://schemas.microsoft.com/office/drawing/2014/main" id="{406CDBB2-E937-D54D-9EE3-D793495633D5}"/>
                </a:ext>
              </a:extLst>
            </p:cNvPr>
            <p:cNvGrpSpPr/>
            <p:nvPr/>
          </p:nvGrpSpPr>
          <p:grpSpPr>
            <a:xfrm>
              <a:off x="1587536" y="728662"/>
              <a:ext cx="8165961" cy="5516312"/>
              <a:chOff x="1587536" y="728662"/>
              <a:chExt cx="8165961" cy="5516312"/>
            </a:xfrm>
          </p:grpSpPr>
          <p:grpSp>
            <p:nvGrpSpPr>
              <p:cNvPr id="514" name="グループ化 513">
                <a:extLst>
                  <a:ext uri="{FF2B5EF4-FFF2-40B4-BE49-F238E27FC236}">
                    <a16:creationId xmlns:a16="http://schemas.microsoft.com/office/drawing/2014/main" id="{E9E8E038-3D94-9E4E-99BE-0BC7DB8510FD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522" name="グループ化 521">
                  <a:extLst>
                    <a:ext uri="{FF2B5EF4-FFF2-40B4-BE49-F238E27FC236}">
                      <a16:creationId xmlns:a16="http://schemas.microsoft.com/office/drawing/2014/main" id="{85F8917F-25B6-9A40-AAFF-5EF612B8E141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529" name="直線コネクタ 528">
                    <a:extLst>
                      <a:ext uri="{FF2B5EF4-FFF2-40B4-BE49-F238E27FC236}">
                        <a16:creationId xmlns:a16="http://schemas.microsoft.com/office/drawing/2014/main" id="{56D46EC3-DBB6-704E-B816-115C5EFFC266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0" name="直線コネクタ 529">
                    <a:extLst>
                      <a:ext uri="{FF2B5EF4-FFF2-40B4-BE49-F238E27FC236}">
                        <a16:creationId xmlns:a16="http://schemas.microsoft.com/office/drawing/2014/main" id="{C52010F5-D456-2F47-9539-133B8400E71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1" name="直線コネクタ 530">
                    <a:extLst>
                      <a:ext uri="{FF2B5EF4-FFF2-40B4-BE49-F238E27FC236}">
                        <a16:creationId xmlns:a16="http://schemas.microsoft.com/office/drawing/2014/main" id="{3C0DBAD1-BEF9-7143-9F78-80918C9824AC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2" name="直線コネクタ 531">
                    <a:extLst>
                      <a:ext uri="{FF2B5EF4-FFF2-40B4-BE49-F238E27FC236}">
                        <a16:creationId xmlns:a16="http://schemas.microsoft.com/office/drawing/2014/main" id="{C2281A05-6CBF-F54D-AFB3-F831E24D10DD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3" name="直線コネクタ 532">
                    <a:extLst>
                      <a:ext uri="{FF2B5EF4-FFF2-40B4-BE49-F238E27FC236}">
                        <a16:creationId xmlns:a16="http://schemas.microsoft.com/office/drawing/2014/main" id="{1F1A9820-B5E6-434A-89A6-2E80D8FAC936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4" name="直線コネクタ 533">
                    <a:extLst>
                      <a:ext uri="{FF2B5EF4-FFF2-40B4-BE49-F238E27FC236}">
                        <a16:creationId xmlns:a16="http://schemas.microsoft.com/office/drawing/2014/main" id="{7FE9333B-CE54-F441-8DFC-6C1376CB4957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5" name="直線コネクタ 534">
                    <a:extLst>
                      <a:ext uri="{FF2B5EF4-FFF2-40B4-BE49-F238E27FC236}">
                        <a16:creationId xmlns:a16="http://schemas.microsoft.com/office/drawing/2014/main" id="{D90DB87F-285B-3E44-9187-AD59B43A91DE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6" name="直線コネクタ 535">
                    <a:extLst>
                      <a:ext uri="{FF2B5EF4-FFF2-40B4-BE49-F238E27FC236}">
                        <a16:creationId xmlns:a16="http://schemas.microsoft.com/office/drawing/2014/main" id="{93D3E060-D89A-6C4C-91D4-F0424967174A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7" name="直線コネクタ 536">
                    <a:extLst>
                      <a:ext uri="{FF2B5EF4-FFF2-40B4-BE49-F238E27FC236}">
                        <a16:creationId xmlns:a16="http://schemas.microsoft.com/office/drawing/2014/main" id="{8A6ACB4A-820D-AD4D-8FF1-BBF9FC7B64FB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8" name="直線コネクタ 537">
                    <a:extLst>
                      <a:ext uri="{FF2B5EF4-FFF2-40B4-BE49-F238E27FC236}">
                        <a16:creationId xmlns:a16="http://schemas.microsoft.com/office/drawing/2014/main" id="{4A59E957-D354-EC42-8FAA-361ABB4F9877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9" name="直線コネクタ 538">
                    <a:extLst>
                      <a:ext uri="{FF2B5EF4-FFF2-40B4-BE49-F238E27FC236}">
                        <a16:creationId xmlns:a16="http://schemas.microsoft.com/office/drawing/2014/main" id="{D18F4697-A04D-C340-920B-50A07ED419E8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0" name="直線コネクタ 539">
                    <a:extLst>
                      <a:ext uri="{FF2B5EF4-FFF2-40B4-BE49-F238E27FC236}">
                        <a16:creationId xmlns:a16="http://schemas.microsoft.com/office/drawing/2014/main" id="{9F1D1078-CB59-184B-94DA-0AF9542EAA78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3" name="グループ化 522">
                  <a:extLst>
                    <a:ext uri="{FF2B5EF4-FFF2-40B4-BE49-F238E27FC236}">
                      <a16:creationId xmlns:a16="http://schemas.microsoft.com/office/drawing/2014/main" id="{A1B221C5-0DFE-8949-A497-6C8474003EE7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524" name="直線コネクタ 523">
                    <a:extLst>
                      <a:ext uri="{FF2B5EF4-FFF2-40B4-BE49-F238E27FC236}">
                        <a16:creationId xmlns:a16="http://schemas.microsoft.com/office/drawing/2014/main" id="{0FDF1058-4E6A-BE40-A0EB-43FB074AA5C3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5" name="直線コネクタ 524">
                    <a:extLst>
                      <a:ext uri="{FF2B5EF4-FFF2-40B4-BE49-F238E27FC236}">
                        <a16:creationId xmlns:a16="http://schemas.microsoft.com/office/drawing/2014/main" id="{E54053EC-2A4F-8245-9E74-368013DBD918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6" name="直線コネクタ 525">
                    <a:extLst>
                      <a:ext uri="{FF2B5EF4-FFF2-40B4-BE49-F238E27FC236}">
                        <a16:creationId xmlns:a16="http://schemas.microsoft.com/office/drawing/2014/main" id="{EDBCD8DB-F69D-5540-B22C-38FE55EFC109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7" name="直線コネクタ 526">
                    <a:extLst>
                      <a:ext uri="{FF2B5EF4-FFF2-40B4-BE49-F238E27FC236}">
                        <a16:creationId xmlns:a16="http://schemas.microsoft.com/office/drawing/2014/main" id="{7DAFE4C9-312F-6945-8438-2EBE69B14A4C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8" name="直線コネクタ 527">
                    <a:extLst>
                      <a:ext uri="{FF2B5EF4-FFF2-40B4-BE49-F238E27FC236}">
                        <a16:creationId xmlns:a16="http://schemas.microsoft.com/office/drawing/2014/main" id="{BB307107-4DA3-6F4E-9A17-B8040921EE48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15" name="グループ化 514">
                <a:extLst>
                  <a:ext uri="{FF2B5EF4-FFF2-40B4-BE49-F238E27FC236}">
                    <a16:creationId xmlns:a16="http://schemas.microsoft.com/office/drawing/2014/main" id="{96BC6435-35AA-EF44-8DF3-4111777C34EA}"/>
                  </a:ext>
                </a:extLst>
              </p:cNvPr>
              <p:cNvGrpSpPr/>
              <p:nvPr/>
            </p:nvGrpSpPr>
            <p:grpSpPr>
              <a:xfrm>
                <a:off x="1587536" y="5875641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516" name="テキスト ボックス 515">
                  <a:extLst>
                    <a:ext uri="{FF2B5EF4-FFF2-40B4-BE49-F238E27FC236}">
                      <a16:creationId xmlns:a16="http://schemas.microsoft.com/office/drawing/2014/main" id="{8D288850-1241-9E48-9252-1A252EB94A7F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7" name="テキスト ボックス 516">
                  <a:extLst>
                    <a:ext uri="{FF2B5EF4-FFF2-40B4-BE49-F238E27FC236}">
                      <a16:creationId xmlns:a16="http://schemas.microsoft.com/office/drawing/2014/main" id="{ECDA0459-80EB-1449-A929-E6A9DE6632EE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8" name="テキスト ボックス 517">
                  <a:extLst>
                    <a:ext uri="{FF2B5EF4-FFF2-40B4-BE49-F238E27FC236}">
                      <a16:creationId xmlns:a16="http://schemas.microsoft.com/office/drawing/2014/main" id="{261D7126-F051-E244-B682-E65B6000C523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9" name="テキスト ボックス 518">
                  <a:extLst>
                    <a:ext uri="{FF2B5EF4-FFF2-40B4-BE49-F238E27FC236}">
                      <a16:creationId xmlns:a16="http://schemas.microsoft.com/office/drawing/2014/main" id="{161C2DCB-C3AA-554A-8CEA-9CAB1C466A71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0" name="テキスト ボックス 519">
                  <a:extLst>
                    <a:ext uri="{FF2B5EF4-FFF2-40B4-BE49-F238E27FC236}">
                      <a16:creationId xmlns:a16="http://schemas.microsoft.com/office/drawing/2014/main" id="{556263A3-0B6E-DC44-A9AB-BE6D757017C9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1" name="テキスト ボックス 520">
                  <a:extLst>
                    <a:ext uri="{FF2B5EF4-FFF2-40B4-BE49-F238E27FC236}">
                      <a16:creationId xmlns:a16="http://schemas.microsoft.com/office/drawing/2014/main" id="{F231D0BD-F556-4544-B08A-22E9E414FED0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508" name="テキスト ボックス 507">
              <a:extLst>
                <a:ext uri="{FF2B5EF4-FFF2-40B4-BE49-F238E27FC236}">
                  <a16:creationId xmlns:a16="http://schemas.microsoft.com/office/drawing/2014/main" id="{56AD7A86-AA16-984A-ADED-77C23A3008E1}"/>
                </a:ext>
              </a:extLst>
            </p:cNvPr>
            <p:cNvSpPr txBox="1"/>
            <p:nvPr/>
          </p:nvSpPr>
          <p:spPr>
            <a:xfrm>
              <a:off x="1198823" y="55938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テキスト ボックス 508">
              <a:extLst>
                <a:ext uri="{FF2B5EF4-FFF2-40B4-BE49-F238E27FC236}">
                  <a16:creationId xmlns:a16="http://schemas.microsoft.com/office/drawing/2014/main" id="{AD2EE17F-12CD-F347-8199-0A150C162269}"/>
                </a:ext>
              </a:extLst>
            </p:cNvPr>
            <p:cNvSpPr txBox="1"/>
            <p:nvPr/>
          </p:nvSpPr>
          <p:spPr>
            <a:xfrm>
              <a:off x="1198823" y="154963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テキスト ボックス 509">
              <a:extLst>
                <a:ext uri="{FF2B5EF4-FFF2-40B4-BE49-F238E27FC236}">
                  <a16:creationId xmlns:a16="http://schemas.microsoft.com/office/drawing/2014/main" id="{10526FDB-7A51-9B4C-A89B-A65FD7A64E00}"/>
                </a:ext>
              </a:extLst>
            </p:cNvPr>
            <p:cNvSpPr txBox="1"/>
            <p:nvPr/>
          </p:nvSpPr>
          <p:spPr>
            <a:xfrm>
              <a:off x="1198696" y="2539878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テキスト ボックス 510">
              <a:extLst>
                <a:ext uri="{FF2B5EF4-FFF2-40B4-BE49-F238E27FC236}">
                  <a16:creationId xmlns:a16="http://schemas.microsoft.com/office/drawing/2014/main" id="{A23BC461-8A89-594E-840A-A425B6160815}"/>
                </a:ext>
              </a:extLst>
            </p:cNvPr>
            <p:cNvSpPr txBox="1"/>
            <p:nvPr/>
          </p:nvSpPr>
          <p:spPr>
            <a:xfrm>
              <a:off x="1198696" y="3530123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テキスト ボックス 511">
              <a:extLst>
                <a:ext uri="{FF2B5EF4-FFF2-40B4-BE49-F238E27FC236}">
                  <a16:creationId xmlns:a16="http://schemas.microsoft.com/office/drawing/2014/main" id="{A87C5923-D33E-2A44-ABFC-EA330E0106D1}"/>
                </a:ext>
              </a:extLst>
            </p:cNvPr>
            <p:cNvSpPr txBox="1"/>
            <p:nvPr/>
          </p:nvSpPr>
          <p:spPr>
            <a:xfrm>
              <a:off x="1198696" y="455111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テキスト ボックス 512">
              <a:extLst>
                <a:ext uri="{FF2B5EF4-FFF2-40B4-BE49-F238E27FC236}">
                  <a16:creationId xmlns:a16="http://schemas.microsoft.com/office/drawing/2014/main" id="{C87C34A9-8163-034D-9555-A6E4613C7BF2}"/>
                </a:ext>
              </a:extLst>
            </p:cNvPr>
            <p:cNvSpPr txBox="1"/>
            <p:nvPr/>
          </p:nvSpPr>
          <p:spPr>
            <a:xfrm>
              <a:off x="1198696" y="554135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1" name="テキスト ボックス 540">
            <a:extLst>
              <a:ext uri="{FF2B5EF4-FFF2-40B4-BE49-F238E27FC236}">
                <a16:creationId xmlns:a16="http://schemas.microsoft.com/office/drawing/2014/main" id="{9D1DC4E6-5261-0249-A3B4-ECCE98DD2CF3}"/>
              </a:ext>
            </a:extLst>
          </p:cNvPr>
          <p:cNvSpPr txBox="1"/>
          <p:nvPr/>
        </p:nvSpPr>
        <p:spPr>
          <a:xfrm rot="16200000">
            <a:off x="-319167" y="2995531"/>
            <a:ext cx="2970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テキスト ボックス 541">
            <a:extLst>
              <a:ext uri="{FF2B5EF4-FFF2-40B4-BE49-F238E27FC236}">
                <a16:creationId xmlns:a16="http://schemas.microsoft.com/office/drawing/2014/main" id="{52A1AB0B-9EB1-2841-B501-AE9826495C7A}"/>
              </a:ext>
            </a:extLst>
          </p:cNvPr>
          <p:cNvSpPr txBox="1"/>
          <p:nvPr/>
        </p:nvSpPr>
        <p:spPr>
          <a:xfrm>
            <a:off x="4753346" y="6105258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43" name="表 2">
            <a:extLst>
              <a:ext uri="{FF2B5EF4-FFF2-40B4-BE49-F238E27FC236}">
                <a16:creationId xmlns:a16="http://schemas.microsoft.com/office/drawing/2014/main" id="{046C0E57-00E8-5F45-84B8-F62D6B43C2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7729924"/>
              </p:ext>
            </p:extLst>
          </p:nvPr>
        </p:nvGraphicFramePr>
        <p:xfrm>
          <a:off x="4515784" y="719972"/>
          <a:ext cx="4790480" cy="2072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97620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2774130465"/>
                    </a:ext>
                  </a:extLst>
                </a:gridCol>
                <a:gridCol w="1197620">
                  <a:extLst>
                    <a:ext uri="{9D8B030D-6E8A-4147-A177-3AD203B41FA5}">
                      <a16:colId xmlns:a16="http://schemas.microsoft.com/office/drawing/2014/main" val="1774716991"/>
                    </a:ext>
                  </a:extLst>
                </a:gridCol>
              </a:tblGrid>
              <a:tr h="485361"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CI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326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rate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47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–1.85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57)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</a:t>
                      </a:r>
                    </a:p>
                    <a:p>
                      <a:pPr algn="ctr"/>
                      <a:r>
                        <a:rPr lang="en-US" altLang="ja-JP" sz="1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–2.41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  <a:endParaRPr kumimoji="1" lang="ja-JP" altLang="en-US" sz="14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141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277040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BRACELET Study 1">
      <a:dk1>
        <a:srgbClr val="000000"/>
      </a:dk1>
      <a:lt1>
        <a:srgbClr val="FFFFFF"/>
      </a:lt1>
      <a:dk2>
        <a:srgbClr val="454551"/>
      </a:dk2>
      <a:lt2>
        <a:srgbClr val="D8D9DC"/>
      </a:lt2>
      <a:accent1>
        <a:srgbClr val="E8003E"/>
      </a:accent1>
      <a:accent2>
        <a:srgbClr val="C830CC"/>
      </a:accent2>
      <a:accent3>
        <a:srgbClr val="4EA6DC"/>
      </a:accent3>
      <a:accent4>
        <a:srgbClr val="00559B"/>
      </a:accent4>
      <a:accent5>
        <a:srgbClr val="8971E1"/>
      </a:accent5>
      <a:accent6>
        <a:srgbClr val="D54773"/>
      </a:accent6>
      <a:hlink>
        <a:srgbClr val="B30658"/>
      </a:hlink>
      <a:folHlink>
        <a:srgbClr val="00559B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JOG13219G template" id="{C2A2FF71-2FFF-A542-8AB3-4CC5D1F2FF7E}" vid="{84F2038F-6506-2841-81A3-3FBB7B3A4003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2</TotalTime>
  <Words>77</Words>
  <Application>Microsoft Macintosh PowerPoint</Application>
  <PresentationFormat>ユーザー設定</PresentationFormat>
  <Paragraphs>3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嵜 啓太郎</dc:creator>
  <cp:lastModifiedBy>下嵜啓太郎</cp:lastModifiedBy>
  <cp:revision>216</cp:revision>
  <cp:lastPrinted>2021-03-12T09:49:31Z</cp:lastPrinted>
  <dcterms:created xsi:type="dcterms:W3CDTF">2021-02-06T04:10:30Z</dcterms:created>
  <dcterms:modified xsi:type="dcterms:W3CDTF">2021-06-17T05:57:46Z</dcterms:modified>
</cp:coreProperties>
</file>